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0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gali Williamson" userId="f2b0579f-917e-48f1-8ba7-ebc52c677f0d" providerId="ADAL" clId="{690B79C2-C519-45EC-9911-0B7B02012EE6}"/>
    <pc:docChg chg="delSld">
      <pc:chgData name="Magali Williamson" userId="f2b0579f-917e-48f1-8ba7-ebc52c677f0d" providerId="ADAL" clId="{690B79C2-C519-45EC-9911-0B7B02012EE6}" dt="2023-06-02T16:46:51.572" v="0" actId="2696"/>
      <pc:docMkLst>
        <pc:docMk/>
      </pc:docMkLst>
      <pc:sldChg chg="del">
        <pc:chgData name="Magali Williamson" userId="f2b0579f-917e-48f1-8ba7-ebc52c677f0d" providerId="ADAL" clId="{690B79C2-C519-45EC-9911-0B7B02012EE6}" dt="2023-06-02T16:46:51.572" v="0" actId="2696"/>
        <pc:sldMkLst>
          <pc:docMk/>
          <pc:sldMk cId="2296473251" sldId="256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F59DC6-5E5F-0EDA-3636-A4A1674F33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EEAD983-272E-19BB-0512-8121570940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63CD34-C641-67A4-67BD-FB4D535DCD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6969C-7586-42B2-80F7-6DE7F08A6A7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BAFBB2-0381-792A-AD36-37B3647B6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4C813A-D17F-D4C1-62EB-6F34F20B23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EE38-14F6-4BF4-8F0E-87438E5C3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67524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0DCCCB-4FC1-CF83-53CF-3DE54B4219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AD66C3-051D-C70B-3412-FFA113E555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5D3E71-7956-14E5-AD65-E1DA07E22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6969C-7586-42B2-80F7-6DE7F08A6A7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01AC7F-0B6B-0EE8-7AD5-05C3D99E63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96B961-01B4-FC83-A061-A6067E709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EE38-14F6-4BF4-8F0E-87438E5C3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20476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A133F73-3B1B-DB69-475C-CFDCF71CEC8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96E80E-9E5C-1CF0-9D80-1A5B8A11F2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FFA501-E651-FEB8-6323-47AAD38D07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6969C-7586-42B2-80F7-6DE7F08A6A7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058EEF-33DC-E92F-5713-4172018D0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D8A845-F3CF-41FF-1353-60C5AA9FDE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EE38-14F6-4BF4-8F0E-87438E5C3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0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03695A-7938-4412-17CA-4AA96FB6E2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9BB204-77AD-C5BA-65BE-914350D5B1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375D4B-6EDA-AE6A-D0F2-974C12961E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6969C-7586-42B2-80F7-6DE7F08A6A7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572D13-918F-DCB2-9A59-41C03DAD21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170A93-9897-6AD1-AE8D-ED012F7FA4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EE38-14F6-4BF4-8F0E-87438E5C3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0063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25C8A0-B157-1A33-53E4-A7FC5EB97F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12D711-74E0-B156-16EE-6C278C418A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8FC596-7FCB-4194-2064-37A05B563C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6969C-7586-42B2-80F7-6DE7F08A6A7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D48799-D908-23B8-6523-68C4D04984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8AEC30-35CC-C27A-7958-380B4E45D2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EE38-14F6-4BF4-8F0E-87438E5C3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95149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F928EA-0B83-9777-5C2F-F42075DB13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5555C8-5313-4102-3AE6-CD8BAAF0AA5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4B56BF-56C7-4205-0756-4710B8C320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75DDC7-8882-F6B1-F3CC-FAE2A6936C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6969C-7586-42B2-80F7-6DE7F08A6A7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E79E79-A578-C8C5-0EC2-87DC381A0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942082-730E-9AAB-9648-C59873472A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EE38-14F6-4BF4-8F0E-87438E5C3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9919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BB375F-33CD-8D84-204C-1ADD51862E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36EA03-79E4-822A-DBDF-2C34259BB1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D8CAD7-47F0-383E-1EC1-F9C6FC08E2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0E3849C-3A80-B97C-1D13-66DD41A91A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499FAE4-E390-FCB2-4509-B992FA4F5D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AC257C7-D59F-72B1-BAE7-5E4850BA8B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6969C-7586-42B2-80F7-6DE7F08A6A7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1D3AE99-A944-AEB7-F07E-566EF91FD3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CCD7238-750C-AE8B-A072-8D7EDCD132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EE38-14F6-4BF4-8F0E-87438E5C3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32687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0CBEBD-0C95-8450-3EE8-FC164AA549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17AAB91-8F78-5346-6465-24C8433427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6969C-7586-42B2-80F7-6DE7F08A6A7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7DE4275-05A5-0BF3-1E3F-1375D7B0E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1155C92-556E-3C62-B9CA-3EB834A11E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EE38-14F6-4BF4-8F0E-87438E5C3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4359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753E90B-3D8B-E8A9-4DFF-C6D53CDD3F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6969C-7586-42B2-80F7-6DE7F08A6A7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7BC4B7D-7A50-94CC-1C2E-E99263338F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55271E3-E870-43C1-0ECE-DA2CF7C4D6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EE38-14F6-4BF4-8F0E-87438E5C3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5860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3FC903-0937-7167-43D7-C2D387434E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5F881B-78EF-6887-EF36-06838C5129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B689F6-0488-574D-3CB8-F09848CFFD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459597-793E-7934-C26C-1E9E810B6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6969C-7586-42B2-80F7-6DE7F08A6A7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E10EC6-F468-3083-C09C-ED4E8D090E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01D8CD-EA83-3EC7-6976-CE0E7A4D39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EE38-14F6-4BF4-8F0E-87438E5C3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5365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FC6761-A996-C90A-9551-01BDF87B52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9C5A425-8FB6-6649-086C-7DB9A06597B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FC9D91E-678B-E066-B179-75F8184BCB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F0CC4D-193D-B45B-91BB-A2354C961E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6969C-7586-42B2-80F7-6DE7F08A6A7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FE509C-C53A-387C-3A2F-55D25B15AC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38FEEE-77CA-05D2-92A1-CA88EE18B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EE38-14F6-4BF4-8F0E-87438E5C3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23514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C102370-1F79-DFCE-2048-71CDF3399C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6095C9-ADAB-110E-2D37-6E7F007EFB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2B1C8D-0C62-F0AF-44A7-B401275723F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6969C-7586-42B2-80F7-6DE7F08A6A7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D8DF4C-2459-D6F3-398A-B5996574A7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7B76DC-6613-7ADF-CC37-91C67C3E028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CCEE38-14F6-4BF4-8F0E-87438E5C3E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4889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Picture 61" descr="Timeline&#10;&#10;Description automatically generated with medium confidence">
            <a:extLst>
              <a:ext uri="{FF2B5EF4-FFF2-40B4-BE49-F238E27FC236}">
                <a16:creationId xmlns:a16="http://schemas.microsoft.com/office/drawing/2014/main" id="{0B1F9A0E-4C74-4B33-9A7B-16A1B7AE65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7341" y="1238246"/>
            <a:ext cx="3200555" cy="1231173"/>
          </a:xfrm>
          <a:prstGeom prst="rect">
            <a:avLst/>
          </a:prstGeom>
        </p:spPr>
      </p:pic>
      <p:grpSp>
        <p:nvGrpSpPr>
          <p:cNvPr id="194" name="Group 193">
            <a:extLst>
              <a:ext uri="{FF2B5EF4-FFF2-40B4-BE49-F238E27FC236}">
                <a16:creationId xmlns:a16="http://schemas.microsoft.com/office/drawing/2014/main" id="{84815F88-A4FE-403F-9F14-0363EF7C5E3D}"/>
              </a:ext>
            </a:extLst>
          </p:cNvPr>
          <p:cNvGrpSpPr/>
          <p:nvPr/>
        </p:nvGrpSpPr>
        <p:grpSpPr>
          <a:xfrm>
            <a:off x="3595621" y="-40265"/>
            <a:ext cx="3369037" cy="5003282"/>
            <a:chOff x="5328632" y="534661"/>
            <a:chExt cx="3369037" cy="5003282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A081D622-0B65-4C03-88F9-EF6159AB369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692269" y="5100497"/>
              <a:ext cx="1738756" cy="437446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BCFD72D3-4EDB-4A09-B925-09B850F1822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692269" y="4719879"/>
              <a:ext cx="1738756" cy="341870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612C1EC-8C0E-4075-88D3-8A38403CEC85}"/>
                </a:ext>
              </a:extLst>
            </p:cNvPr>
            <p:cNvSpPr txBox="1"/>
            <p:nvPr/>
          </p:nvSpPr>
          <p:spPr>
            <a:xfrm>
              <a:off x="7411689" y="4007149"/>
              <a:ext cx="12652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HA(cytoPlexinB1)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7EE4FEF-3F9B-4CEC-994F-50456709E854}"/>
                </a:ext>
              </a:extLst>
            </p:cNvPr>
            <p:cNvSpPr txBox="1"/>
            <p:nvPr/>
          </p:nvSpPr>
          <p:spPr>
            <a:xfrm>
              <a:off x="7432386" y="3192118"/>
              <a:ext cx="12652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HA(cytoPlexinB1)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77B10F8-7510-493D-8FDF-362B0DC266E0}"/>
                </a:ext>
              </a:extLst>
            </p:cNvPr>
            <p:cNvSpPr txBox="1"/>
            <p:nvPr/>
          </p:nvSpPr>
          <p:spPr>
            <a:xfrm>
              <a:off x="7387925" y="4627735"/>
              <a:ext cx="7575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GST(Ran)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25657BF-EDAA-4B76-B7EA-FCE713F7CE16}"/>
                </a:ext>
              </a:extLst>
            </p:cNvPr>
            <p:cNvSpPr txBox="1"/>
            <p:nvPr/>
          </p:nvSpPr>
          <p:spPr>
            <a:xfrm>
              <a:off x="7390709" y="2360844"/>
              <a:ext cx="12652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HA(cytoPlexinB1)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2A30C35-2BE0-495E-B88E-13C18BC7AA01}"/>
                </a:ext>
              </a:extLst>
            </p:cNvPr>
            <p:cNvSpPr txBox="1"/>
            <p:nvPr/>
          </p:nvSpPr>
          <p:spPr>
            <a:xfrm rot="16200000">
              <a:off x="4993797" y="2267862"/>
              <a:ext cx="9466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1P: GST-Ra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2FB2DB8-7734-4E8B-8066-C69641D73A0D}"/>
                </a:ext>
              </a:extLst>
            </p:cNvPr>
            <p:cNvSpPr txBox="1"/>
            <p:nvPr/>
          </p:nvSpPr>
          <p:spPr>
            <a:xfrm rot="16200000">
              <a:off x="5161723" y="4196676"/>
              <a:ext cx="667829" cy="3340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input</a:t>
              </a:r>
            </a:p>
          </p:txBody>
        </p: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76C7172C-7D33-4C28-A910-40898FBE6B44}"/>
                </a:ext>
              </a:extLst>
            </p:cNvPr>
            <p:cNvCxnSpPr>
              <a:cxnSpLocks/>
            </p:cNvCxnSpPr>
            <p:nvPr/>
          </p:nvCxnSpPr>
          <p:spPr>
            <a:xfrm>
              <a:off x="5599016" y="2009974"/>
              <a:ext cx="0" cy="78880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A38DFC61-E0B9-4ADA-9C98-F806E975BE17}"/>
                </a:ext>
              </a:extLst>
            </p:cNvPr>
            <p:cNvCxnSpPr>
              <a:cxnSpLocks/>
            </p:cNvCxnSpPr>
            <p:nvPr/>
          </p:nvCxnSpPr>
          <p:spPr>
            <a:xfrm>
              <a:off x="5599016" y="3890503"/>
              <a:ext cx="0" cy="151666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E588071F-BD5D-4498-90CD-FBA3CD7559A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674203" y="2957361"/>
              <a:ext cx="1756493" cy="794693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C3C0080-A315-4D3B-8D7A-EF3D48E16461}"/>
                </a:ext>
              </a:extLst>
            </p:cNvPr>
            <p:cNvSpPr txBox="1"/>
            <p:nvPr/>
          </p:nvSpPr>
          <p:spPr>
            <a:xfrm>
              <a:off x="7404632" y="4989649"/>
              <a:ext cx="4272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GST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460BA3D-EE8F-4113-9633-FA0E75DEDA0A}"/>
                </a:ext>
              </a:extLst>
            </p:cNvPr>
            <p:cNvSpPr txBox="1"/>
            <p:nvPr/>
          </p:nvSpPr>
          <p:spPr>
            <a:xfrm rot="16200000">
              <a:off x="5135663" y="3240067"/>
              <a:ext cx="6629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1P: GST</a:t>
              </a:r>
            </a:p>
          </p:txBody>
        </p:sp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CE1EF086-F434-4FC8-A119-ED67CD742E6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679257" y="1928764"/>
              <a:ext cx="1749071" cy="990113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FC16B5C5-880F-4956-98BE-538DF6CAC2B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675226" y="3799455"/>
              <a:ext cx="1749072" cy="892494"/>
            </a:xfrm>
            <a:prstGeom prst="rect">
              <a:avLst/>
            </a:prstGeom>
          </p:spPr>
        </p:pic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042F92A2-B559-4E76-8075-D57932937382}"/>
                </a:ext>
              </a:extLst>
            </p:cNvPr>
            <p:cNvSpPr/>
            <p:nvPr/>
          </p:nvSpPr>
          <p:spPr>
            <a:xfrm rot="16200000">
              <a:off x="5397227" y="1034605"/>
              <a:ext cx="1461554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dirty="0"/>
                <a:t>cytoPlxnB1(</a:t>
              </a:r>
              <a:r>
                <a:rPr lang="en-GB" sz="1200" i="1" dirty="0">
                  <a:effectLst/>
                  <a:latin typeface="Calibri" panose="020F0502020204030204" pitchFamily="34" charset="0"/>
                  <a:ea typeface="Calibri" panose="020F0502020204030204" pitchFamily="34" charset="0"/>
                </a:rPr>
                <a:t>P1851G)</a:t>
              </a:r>
              <a:endParaRPr lang="en-GB" sz="1200" dirty="0"/>
            </a:p>
            <a:p>
              <a:endParaRPr lang="en-GB" sz="1200" dirty="0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24F3CDBB-7E71-4447-BFA2-605C7D00CD75}"/>
                </a:ext>
              </a:extLst>
            </p:cNvPr>
            <p:cNvSpPr/>
            <p:nvPr/>
          </p:nvSpPr>
          <p:spPr>
            <a:xfrm rot="16200000">
              <a:off x="5340482" y="1419486"/>
              <a:ext cx="87645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dirty="0"/>
                <a:t>cytoPlxnB1</a:t>
              </a:r>
            </a:p>
          </p:txBody>
        </p: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872A866E-3DD6-4197-B123-05284FCA1520}"/>
                </a:ext>
              </a:extLst>
            </p:cNvPr>
            <p:cNvGrpSpPr/>
            <p:nvPr/>
          </p:nvGrpSpPr>
          <p:grpSpPr>
            <a:xfrm>
              <a:off x="6403455" y="831216"/>
              <a:ext cx="276999" cy="1164999"/>
              <a:chOff x="8997788" y="207199"/>
              <a:chExt cx="276999" cy="1164999"/>
            </a:xfrm>
          </p:grpSpPr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C0A2FB0E-C9B0-4193-8D10-1CD5ADF99FFD}"/>
                  </a:ext>
                </a:extLst>
              </p:cNvPr>
              <p:cNvSpPr/>
              <p:nvPr/>
            </p:nvSpPr>
            <p:spPr>
              <a:xfrm rot="16200000">
                <a:off x="8553788" y="651199"/>
                <a:ext cx="1164999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200" dirty="0"/>
                  <a:t>cytoPlxnB1     5’</a:t>
                </a:r>
              </a:p>
            </p:txBody>
          </p:sp>
          <p:sp>
            <p:nvSpPr>
              <p:cNvPr id="35" name="Isosceles Triangle 34">
                <a:extLst>
                  <a:ext uri="{FF2B5EF4-FFF2-40B4-BE49-F238E27FC236}">
                    <a16:creationId xmlns:a16="http://schemas.microsoft.com/office/drawing/2014/main" id="{2ED063EE-94DB-485D-9B5D-CED59F565755}"/>
                  </a:ext>
                </a:extLst>
              </p:cNvPr>
              <p:cNvSpPr/>
              <p:nvPr/>
            </p:nvSpPr>
            <p:spPr>
              <a:xfrm rot="16200000">
                <a:off x="9028860" y="403600"/>
                <a:ext cx="173024" cy="179837"/>
              </a:xfrm>
              <a:prstGeom prst="triangl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6132EEC5-B71C-425D-ABD4-2FD46CE85AEC}"/>
                </a:ext>
              </a:extLst>
            </p:cNvPr>
            <p:cNvGrpSpPr/>
            <p:nvPr/>
          </p:nvGrpSpPr>
          <p:grpSpPr>
            <a:xfrm>
              <a:off x="6664380" y="831216"/>
              <a:ext cx="276999" cy="1164999"/>
              <a:chOff x="8997788" y="207199"/>
              <a:chExt cx="276999" cy="1164999"/>
            </a:xfrm>
          </p:grpSpPr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94F3F7E1-92A1-4EF2-84B2-378D67AEEFB3}"/>
                  </a:ext>
                </a:extLst>
              </p:cNvPr>
              <p:cNvSpPr/>
              <p:nvPr/>
            </p:nvSpPr>
            <p:spPr>
              <a:xfrm rot="16200000">
                <a:off x="8553788" y="651199"/>
                <a:ext cx="1164999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200" dirty="0"/>
                  <a:t>cytoPlxnB1     3’</a:t>
                </a:r>
              </a:p>
            </p:txBody>
          </p:sp>
          <p:sp>
            <p:nvSpPr>
              <p:cNvPr id="33" name="Isosceles Triangle 32">
                <a:extLst>
                  <a:ext uri="{FF2B5EF4-FFF2-40B4-BE49-F238E27FC236}">
                    <a16:creationId xmlns:a16="http://schemas.microsoft.com/office/drawing/2014/main" id="{015E6403-1B0C-46FC-A793-5C633D998791}"/>
                  </a:ext>
                </a:extLst>
              </p:cNvPr>
              <p:cNvSpPr/>
              <p:nvPr/>
            </p:nvSpPr>
            <p:spPr>
              <a:xfrm rot="16200000">
                <a:off x="9028860" y="403600"/>
                <a:ext cx="173024" cy="179837"/>
              </a:xfrm>
              <a:prstGeom prst="triangl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F1374E2B-C56E-4CB0-93A4-2BFC9FC7B868}"/>
                </a:ext>
              </a:extLst>
            </p:cNvPr>
            <p:cNvGrpSpPr/>
            <p:nvPr/>
          </p:nvGrpSpPr>
          <p:grpSpPr>
            <a:xfrm>
              <a:off x="6170195" y="682137"/>
              <a:ext cx="276999" cy="1314078"/>
              <a:chOff x="8997788" y="132660"/>
              <a:chExt cx="276999" cy="1314078"/>
            </a:xfrm>
          </p:grpSpPr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3A665CFD-81DE-46D9-B503-691C989DC7D2}"/>
                  </a:ext>
                </a:extLst>
              </p:cNvPr>
              <p:cNvSpPr/>
              <p:nvPr/>
            </p:nvSpPr>
            <p:spPr>
              <a:xfrm rot="16200000">
                <a:off x="8479249" y="651199"/>
                <a:ext cx="131407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200" dirty="0"/>
                  <a:t>cytoPlxnB1     RBD</a:t>
                </a:r>
              </a:p>
            </p:txBody>
          </p:sp>
          <p:sp>
            <p:nvSpPr>
              <p:cNvPr id="31" name="Isosceles Triangle 30">
                <a:extLst>
                  <a:ext uri="{FF2B5EF4-FFF2-40B4-BE49-F238E27FC236}">
                    <a16:creationId xmlns:a16="http://schemas.microsoft.com/office/drawing/2014/main" id="{6030F209-E99A-46F4-81A1-7C93ED563C31}"/>
                  </a:ext>
                </a:extLst>
              </p:cNvPr>
              <p:cNvSpPr/>
              <p:nvPr/>
            </p:nvSpPr>
            <p:spPr>
              <a:xfrm rot="16200000">
                <a:off x="9019765" y="489531"/>
                <a:ext cx="173024" cy="179837"/>
              </a:xfrm>
              <a:prstGeom prst="triangl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894FAF2-B837-4086-8CB7-E5D9BA18A7E0}"/>
                </a:ext>
              </a:extLst>
            </p:cNvPr>
            <p:cNvSpPr txBox="1"/>
            <p:nvPr/>
          </p:nvSpPr>
          <p:spPr>
            <a:xfrm rot="16200000">
              <a:off x="6625576" y="1419486"/>
              <a:ext cx="876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cytoPlxnB2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E8D54F8-BA66-41B0-8679-D09C249E1635}"/>
                </a:ext>
              </a:extLst>
            </p:cNvPr>
            <p:cNvSpPr txBox="1"/>
            <p:nvPr/>
          </p:nvSpPr>
          <p:spPr>
            <a:xfrm rot="16200000">
              <a:off x="6858999" y="1419486"/>
              <a:ext cx="876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cytoPlxnB3</a:t>
              </a:r>
            </a:p>
          </p:txBody>
        </p:sp>
        <p:cxnSp>
          <p:nvCxnSpPr>
            <p:cNvPr id="192" name="Straight Connector 191">
              <a:extLst>
                <a:ext uri="{FF2B5EF4-FFF2-40B4-BE49-F238E27FC236}">
                  <a16:creationId xmlns:a16="http://schemas.microsoft.com/office/drawing/2014/main" id="{7301972B-9A40-4B2A-96BA-F6186801E6A3}"/>
                </a:ext>
              </a:extLst>
            </p:cNvPr>
            <p:cNvCxnSpPr>
              <a:cxnSpLocks/>
            </p:cNvCxnSpPr>
            <p:nvPr/>
          </p:nvCxnSpPr>
          <p:spPr>
            <a:xfrm>
              <a:off x="5599016" y="2968492"/>
              <a:ext cx="0" cy="78880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id="{E6572677-745F-40C4-8488-AE7E3E1303C9}"/>
                </a:ext>
              </a:extLst>
            </p:cNvPr>
            <p:cNvSpPr txBox="1"/>
            <p:nvPr/>
          </p:nvSpPr>
          <p:spPr>
            <a:xfrm>
              <a:off x="7419654" y="1843849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IB:</a:t>
              </a:r>
            </a:p>
          </p:txBody>
        </p:sp>
      </p:grpSp>
      <p:grpSp>
        <p:nvGrpSpPr>
          <p:cNvPr id="209" name="Group 208">
            <a:extLst>
              <a:ext uri="{FF2B5EF4-FFF2-40B4-BE49-F238E27FC236}">
                <a16:creationId xmlns:a16="http://schemas.microsoft.com/office/drawing/2014/main" id="{0EAB474A-F5F4-4307-BB7B-234DD06EC724}"/>
              </a:ext>
            </a:extLst>
          </p:cNvPr>
          <p:cNvGrpSpPr/>
          <p:nvPr/>
        </p:nvGrpSpPr>
        <p:grpSpPr>
          <a:xfrm>
            <a:off x="7091177" y="-236121"/>
            <a:ext cx="3526085" cy="4665028"/>
            <a:chOff x="1395754" y="295266"/>
            <a:chExt cx="3526085" cy="4665028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40E8018-68EB-4C33-9656-2D45E39E064C}"/>
                </a:ext>
              </a:extLst>
            </p:cNvPr>
            <p:cNvSpPr txBox="1"/>
            <p:nvPr/>
          </p:nvSpPr>
          <p:spPr>
            <a:xfrm rot="16200000">
              <a:off x="1167124" y="2347036"/>
              <a:ext cx="791269" cy="3340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1P: HA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8648E4D7-B3DB-4BB5-A774-7EFF78ADDF72}"/>
                </a:ext>
              </a:extLst>
            </p:cNvPr>
            <p:cNvSpPr txBox="1"/>
            <p:nvPr/>
          </p:nvSpPr>
          <p:spPr>
            <a:xfrm rot="16200000">
              <a:off x="1228844" y="3924696"/>
              <a:ext cx="667829" cy="3340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input</a:t>
              </a:r>
            </a:p>
          </p:txBody>
        </p: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D8602B87-41E3-4C2E-B5D6-E03F9079FE0C}"/>
                </a:ext>
              </a:extLst>
            </p:cNvPr>
            <p:cNvCxnSpPr>
              <a:cxnSpLocks/>
            </p:cNvCxnSpPr>
            <p:nvPr/>
          </p:nvCxnSpPr>
          <p:spPr>
            <a:xfrm>
              <a:off x="1650595" y="2092959"/>
              <a:ext cx="0" cy="113054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7738E6FB-07C7-4A0B-A87E-FB3F5103BF03}"/>
                </a:ext>
              </a:extLst>
            </p:cNvPr>
            <p:cNvSpPr txBox="1"/>
            <p:nvPr/>
          </p:nvSpPr>
          <p:spPr>
            <a:xfrm rot="16200000">
              <a:off x="1794024" y="1380826"/>
              <a:ext cx="1036222" cy="3340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Rnd2+vec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B833535E-CCDF-477E-9E1C-2765AD59D8BF}"/>
                </a:ext>
              </a:extLst>
            </p:cNvPr>
            <p:cNvSpPr txBox="1"/>
            <p:nvPr/>
          </p:nvSpPr>
          <p:spPr>
            <a:xfrm rot="16200000">
              <a:off x="2030777" y="1274332"/>
              <a:ext cx="13062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cytoPlxnB1+vec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FD0B4945-8699-41B5-929F-1115B84600FF}"/>
                </a:ext>
              </a:extLst>
            </p:cNvPr>
            <p:cNvSpPr txBox="1"/>
            <p:nvPr/>
          </p:nvSpPr>
          <p:spPr>
            <a:xfrm rot="16200000">
              <a:off x="2741483" y="964959"/>
              <a:ext cx="174030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cytoPlxnB1+ Rnd2</a:t>
              </a:r>
            </a:p>
            <a:p>
              <a:r>
                <a:rPr lang="en-GB" sz="1200" dirty="0"/>
                <a:t>           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9F644E48-63F5-4F03-A318-2C7BBA0BB6EE}"/>
                </a:ext>
              </a:extLst>
            </p:cNvPr>
            <p:cNvSpPr txBox="1"/>
            <p:nvPr/>
          </p:nvSpPr>
          <p:spPr>
            <a:xfrm rot="16200000">
              <a:off x="2319897" y="949772"/>
              <a:ext cx="177067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cytoPlxnB1+RanWT</a:t>
              </a:r>
            </a:p>
            <a:p>
              <a:endParaRPr lang="en-GB" sz="1200" dirty="0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B3DB14E8-0965-4491-B4E1-55E635E8C0DF}"/>
                </a:ext>
              </a:extLst>
            </p:cNvPr>
            <p:cNvSpPr txBox="1"/>
            <p:nvPr/>
          </p:nvSpPr>
          <p:spPr>
            <a:xfrm>
              <a:off x="3652523" y="3454782"/>
              <a:ext cx="1269316" cy="3615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err="1"/>
                <a:t>mCherry</a:t>
              </a:r>
              <a:r>
                <a:rPr lang="en-GB" sz="1200" dirty="0"/>
                <a:t>(Ran)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3D3CD81D-ED9B-40E5-AEA7-CEFA4BDABE37}"/>
                </a:ext>
              </a:extLst>
            </p:cNvPr>
            <p:cNvSpPr txBox="1"/>
            <p:nvPr/>
          </p:nvSpPr>
          <p:spPr>
            <a:xfrm>
              <a:off x="3652523" y="4197550"/>
              <a:ext cx="8883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HA(PlxnB1)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D6FC3987-B6CA-4103-8ACF-1BBDD899209A}"/>
                </a:ext>
              </a:extLst>
            </p:cNvPr>
            <p:cNvSpPr txBox="1"/>
            <p:nvPr/>
          </p:nvSpPr>
          <p:spPr>
            <a:xfrm>
              <a:off x="3652523" y="3042743"/>
              <a:ext cx="1110429" cy="3615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FLAG(Rnd2)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DAC51E7B-1855-47AE-B7DD-DBFA5C386A3E}"/>
                </a:ext>
              </a:extLst>
            </p:cNvPr>
            <p:cNvSpPr txBox="1"/>
            <p:nvPr/>
          </p:nvSpPr>
          <p:spPr>
            <a:xfrm>
              <a:off x="3652523" y="3867770"/>
              <a:ext cx="1110429" cy="3615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FLAG(Rnd2)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E17B8AA4-3B6F-41FA-B19E-553CFC4F3C47}"/>
                </a:ext>
              </a:extLst>
            </p:cNvPr>
            <p:cNvSpPr txBox="1"/>
            <p:nvPr/>
          </p:nvSpPr>
          <p:spPr>
            <a:xfrm>
              <a:off x="3652523" y="2571250"/>
              <a:ext cx="9236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HA(PlxnB1)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6DF374F4-633B-492E-818F-5DD7EF034E7B}"/>
                </a:ext>
              </a:extLst>
            </p:cNvPr>
            <p:cNvSpPr txBox="1"/>
            <p:nvPr/>
          </p:nvSpPr>
          <p:spPr>
            <a:xfrm>
              <a:off x="3652523" y="2092959"/>
              <a:ext cx="1269316" cy="3615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err="1"/>
                <a:t>mCherry</a:t>
              </a:r>
              <a:r>
                <a:rPr lang="en-GB" sz="1200" dirty="0"/>
                <a:t>(Ran)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05B6BC9A-FF76-4DC1-B30A-D32399DED426}"/>
                </a:ext>
              </a:extLst>
            </p:cNvPr>
            <p:cNvSpPr txBox="1"/>
            <p:nvPr/>
          </p:nvSpPr>
          <p:spPr>
            <a:xfrm>
              <a:off x="3652523" y="4598763"/>
              <a:ext cx="775492" cy="3615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GAPDH</a:t>
              </a:r>
            </a:p>
          </p:txBody>
        </p:sp>
        <p:pic>
          <p:nvPicPr>
            <p:cNvPr id="145" name="Picture 144">
              <a:extLst>
                <a:ext uri="{FF2B5EF4-FFF2-40B4-BE49-F238E27FC236}">
                  <a16:creationId xmlns:a16="http://schemas.microsoft.com/office/drawing/2014/main" id="{62F741E5-6461-477F-830A-19BA59D5E51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698439" y="4492426"/>
              <a:ext cx="1619667" cy="371332"/>
            </a:xfrm>
            <a:prstGeom prst="rect">
              <a:avLst/>
            </a:prstGeom>
          </p:spPr>
        </p:pic>
        <p:pic>
          <p:nvPicPr>
            <p:cNvPr id="147" name="Picture 146">
              <a:extLst>
                <a:ext uri="{FF2B5EF4-FFF2-40B4-BE49-F238E27FC236}">
                  <a16:creationId xmlns:a16="http://schemas.microsoft.com/office/drawing/2014/main" id="{D9E0DB6B-EF19-4B3B-8B39-5EE4170D8E30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335765" y="4492426"/>
              <a:ext cx="383696" cy="371332"/>
            </a:xfrm>
            <a:prstGeom prst="rect">
              <a:avLst/>
            </a:prstGeom>
          </p:spPr>
        </p:pic>
        <p:pic>
          <p:nvPicPr>
            <p:cNvPr id="159" name="Picture 158">
              <a:extLst>
                <a:ext uri="{FF2B5EF4-FFF2-40B4-BE49-F238E27FC236}">
                  <a16:creationId xmlns:a16="http://schemas.microsoft.com/office/drawing/2014/main" id="{2A7DEC5F-ACCB-497B-9032-167450ACFA1D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698439" y="2463383"/>
              <a:ext cx="1618341" cy="504824"/>
            </a:xfrm>
            <a:prstGeom prst="rect">
              <a:avLst/>
            </a:prstGeom>
          </p:spPr>
        </p:pic>
        <p:pic>
          <p:nvPicPr>
            <p:cNvPr id="161" name="Picture 160">
              <a:extLst>
                <a:ext uri="{FF2B5EF4-FFF2-40B4-BE49-F238E27FC236}">
                  <a16:creationId xmlns:a16="http://schemas.microsoft.com/office/drawing/2014/main" id="{BB6A3359-A266-4480-ABFB-9887ECE8E758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335764" y="2463383"/>
              <a:ext cx="385033" cy="506177"/>
            </a:xfrm>
            <a:prstGeom prst="rect">
              <a:avLst/>
            </a:prstGeom>
          </p:spPr>
        </p:pic>
        <p:pic>
          <p:nvPicPr>
            <p:cNvPr id="163" name="Picture 162">
              <a:extLst>
                <a:ext uri="{FF2B5EF4-FFF2-40B4-BE49-F238E27FC236}">
                  <a16:creationId xmlns:a16="http://schemas.microsoft.com/office/drawing/2014/main" id="{3C26C3D2-F105-457C-9310-1DB322023BB3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698439" y="3386553"/>
              <a:ext cx="1618342" cy="451762"/>
            </a:xfrm>
            <a:prstGeom prst="rect">
              <a:avLst/>
            </a:prstGeom>
          </p:spPr>
        </p:pic>
        <p:pic>
          <p:nvPicPr>
            <p:cNvPr id="165" name="Picture 164">
              <a:extLst>
                <a:ext uri="{FF2B5EF4-FFF2-40B4-BE49-F238E27FC236}">
                  <a16:creationId xmlns:a16="http://schemas.microsoft.com/office/drawing/2014/main" id="{63FFD12F-52FE-4548-9D70-73C3D29E18DB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335765" y="3386553"/>
              <a:ext cx="385033" cy="451762"/>
            </a:xfrm>
            <a:prstGeom prst="rect">
              <a:avLst/>
            </a:prstGeom>
          </p:spPr>
        </p:pic>
        <p:pic>
          <p:nvPicPr>
            <p:cNvPr id="138" name="Picture 137">
              <a:extLst>
                <a:ext uri="{FF2B5EF4-FFF2-40B4-BE49-F238E27FC236}">
                  <a16:creationId xmlns:a16="http://schemas.microsoft.com/office/drawing/2014/main" id="{41B65B16-16E1-4FA1-BE94-34CF2775431C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3335765" y="3001039"/>
              <a:ext cx="385033" cy="359307"/>
            </a:xfrm>
            <a:prstGeom prst="rect">
              <a:avLst/>
            </a:prstGeom>
          </p:spPr>
        </p:pic>
        <p:pic>
          <p:nvPicPr>
            <p:cNvPr id="167" name="Picture 166">
              <a:extLst>
                <a:ext uri="{FF2B5EF4-FFF2-40B4-BE49-F238E27FC236}">
                  <a16:creationId xmlns:a16="http://schemas.microsoft.com/office/drawing/2014/main" id="{E2ECB267-8A8C-4391-94AC-16D44A2E2314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1698439" y="3001039"/>
              <a:ext cx="1617651" cy="359307"/>
            </a:xfrm>
            <a:prstGeom prst="rect">
              <a:avLst/>
            </a:prstGeom>
          </p:spPr>
        </p:pic>
        <p:pic>
          <p:nvPicPr>
            <p:cNvPr id="171" name="Picture 170">
              <a:extLst>
                <a:ext uri="{FF2B5EF4-FFF2-40B4-BE49-F238E27FC236}">
                  <a16:creationId xmlns:a16="http://schemas.microsoft.com/office/drawing/2014/main" id="{D1905C18-5120-4F7B-877F-EDC5840CFBE6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1698439" y="2011780"/>
              <a:ext cx="1618343" cy="421644"/>
            </a:xfrm>
            <a:prstGeom prst="rect">
              <a:avLst/>
            </a:prstGeom>
          </p:spPr>
        </p:pic>
        <p:pic>
          <p:nvPicPr>
            <p:cNvPr id="173" name="Picture 172">
              <a:extLst>
                <a:ext uri="{FF2B5EF4-FFF2-40B4-BE49-F238E27FC236}">
                  <a16:creationId xmlns:a16="http://schemas.microsoft.com/office/drawing/2014/main" id="{2B170747-23A2-4E7F-8D85-8EA216CD912C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3335765" y="2009974"/>
              <a:ext cx="385033" cy="421644"/>
            </a:xfrm>
            <a:prstGeom prst="rect">
              <a:avLst/>
            </a:prstGeom>
          </p:spPr>
        </p:pic>
        <p:cxnSp>
          <p:nvCxnSpPr>
            <p:cNvPr id="188" name="Straight Connector 187">
              <a:extLst>
                <a:ext uri="{FF2B5EF4-FFF2-40B4-BE49-F238E27FC236}">
                  <a16:creationId xmlns:a16="http://schemas.microsoft.com/office/drawing/2014/main" id="{67499BB1-2C71-4D57-9BB2-FD3C10E7557D}"/>
                </a:ext>
              </a:extLst>
            </p:cNvPr>
            <p:cNvCxnSpPr>
              <a:cxnSpLocks/>
            </p:cNvCxnSpPr>
            <p:nvPr/>
          </p:nvCxnSpPr>
          <p:spPr>
            <a:xfrm>
              <a:off x="1650595" y="3405832"/>
              <a:ext cx="0" cy="144585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31DB1ED0-9BE0-441F-A355-7553E548C93F}"/>
                </a:ext>
              </a:extLst>
            </p:cNvPr>
            <p:cNvSpPr txBox="1"/>
            <p:nvPr/>
          </p:nvSpPr>
          <p:spPr>
            <a:xfrm rot="16200000">
              <a:off x="1266384" y="1308364"/>
              <a:ext cx="123815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1200" dirty="0" err="1"/>
                <a:t>RanWT+vec</a:t>
              </a:r>
              <a:endParaRPr lang="en-GB" sz="1200" dirty="0"/>
            </a:p>
          </p:txBody>
        </p:sp>
        <p:pic>
          <p:nvPicPr>
            <p:cNvPr id="157" name="Picture 156">
              <a:extLst>
                <a:ext uri="{FF2B5EF4-FFF2-40B4-BE49-F238E27FC236}">
                  <a16:creationId xmlns:a16="http://schemas.microsoft.com/office/drawing/2014/main" id="{8AFB1B90-C3B2-4D30-AD54-04A423C6ECC3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3335765" y="3864148"/>
              <a:ext cx="385987" cy="249419"/>
            </a:xfrm>
            <a:prstGeom prst="rect">
              <a:avLst/>
            </a:prstGeom>
          </p:spPr>
        </p:pic>
        <p:pic>
          <p:nvPicPr>
            <p:cNvPr id="201" name="Picture 200">
              <a:extLst>
                <a:ext uri="{FF2B5EF4-FFF2-40B4-BE49-F238E27FC236}">
                  <a16:creationId xmlns:a16="http://schemas.microsoft.com/office/drawing/2014/main" id="{27CA480D-580B-4ACA-8C18-9C9B8192EBEF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1698439" y="3864148"/>
              <a:ext cx="1619032" cy="247031"/>
            </a:xfrm>
            <a:prstGeom prst="rect">
              <a:avLst/>
            </a:prstGeom>
          </p:spPr>
        </p:pic>
        <p:pic>
          <p:nvPicPr>
            <p:cNvPr id="178" name="Picture 177">
              <a:extLst>
                <a:ext uri="{FF2B5EF4-FFF2-40B4-BE49-F238E27FC236}">
                  <a16:creationId xmlns:a16="http://schemas.microsoft.com/office/drawing/2014/main" id="{258854DD-100C-4E87-8FFE-E1F72D7B45D4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3335765" y="4137951"/>
              <a:ext cx="383696" cy="326138"/>
            </a:xfrm>
            <a:prstGeom prst="rect">
              <a:avLst/>
            </a:prstGeom>
          </p:spPr>
        </p:pic>
        <p:pic>
          <p:nvPicPr>
            <p:cNvPr id="203" name="Picture 202">
              <a:extLst>
                <a:ext uri="{FF2B5EF4-FFF2-40B4-BE49-F238E27FC236}">
                  <a16:creationId xmlns:a16="http://schemas.microsoft.com/office/drawing/2014/main" id="{FF1E7314-B7AA-417D-8DDD-4DD38275322E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1698439" y="4137952"/>
              <a:ext cx="1617016" cy="326137"/>
            </a:xfrm>
            <a:prstGeom prst="rect">
              <a:avLst/>
            </a:prstGeom>
          </p:spPr>
        </p:pic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8DA6180B-7A60-4A57-AC3A-311EDB1A38DE}"/>
                </a:ext>
              </a:extLst>
            </p:cNvPr>
            <p:cNvSpPr txBox="1"/>
            <p:nvPr/>
          </p:nvSpPr>
          <p:spPr>
            <a:xfrm>
              <a:off x="3652523" y="1865578"/>
              <a:ext cx="3481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IB:</a:t>
              </a:r>
            </a:p>
          </p:txBody>
        </p:sp>
      </p:grpSp>
      <p:sp>
        <p:nvSpPr>
          <p:cNvPr id="212" name="TextBox 211">
            <a:extLst>
              <a:ext uri="{FF2B5EF4-FFF2-40B4-BE49-F238E27FC236}">
                <a16:creationId xmlns:a16="http://schemas.microsoft.com/office/drawing/2014/main" id="{0D04E43A-017B-46E3-8769-AD1AFEF76F1B}"/>
              </a:ext>
            </a:extLst>
          </p:cNvPr>
          <p:cNvSpPr txBox="1"/>
          <p:nvPr/>
        </p:nvSpPr>
        <p:spPr>
          <a:xfrm>
            <a:off x="217238" y="943997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A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E32A67EA-6834-446E-8435-CE6969969B3F}"/>
              </a:ext>
            </a:extLst>
          </p:cNvPr>
          <p:cNvSpPr txBox="1"/>
          <p:nvPr/>
        </p:nvSpPr>
        <p:spPr>
          <a:xfrm>
            <a:off x="7077343" y="939369"/>
            <a:ext cx="64860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dirty="0"/>
              <a:t>C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500DA83-4DDA-A4E7-4DBF-BF2610AB74C4}"/>
              </a:ext>
            </a:extLst>
          </p:cNvPr>
          <p:cNvSpPr txBox="1"/>
          <p:nvPr/>
        </p:nvSpPr>
        <p:spPr>
          <a:xfrm>
            <a:off x="3527694" y="953537"/>
            <a:ext cx="64860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dirty="0"/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BB30055-BD0A-B9E9-E9EF-00BF79024D8A}"/>
              </a:ext>
            </a:extLst>
          </p:cNvPr>
          <p:cNvSpPr txBox="1"/>
          <p:nvPr/>
        </p:nvSpPr>
        <p:spPr>
          <a:xfrm>
            <a:off x="247341" y="5024046"/>
            <a:ext cx="11051827" cy="189038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Figure</a:t>
            </a:r>
            <a:r>
              <a:rPr lang="en-GB" sz="1200" b="1" kern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9. </a:t>
            </a: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teraction of Ran GTP with PlexinB1 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nd PlexinB2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 (associated with figure 6)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)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</a:t>
            </a: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chematic representation of the cytoplasmic domain and truncated deletion mutants of Plexin B1 used in this study</a:t>
            </a: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)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COS7cells were transiently transfected with plasmids encoding HA-tagged cytoplasmic domain of Plexin B1, Plexin B2 or Plexin B3 or PlexinB1 deletion mutants with either the N- terminal, C-terminal or RBD region of cytoPlexinB1 deleted, or with cytoPlexinB1(</a:t>
            </a:r>
            <a:r>
              <a:rPr lang="en-GB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1851G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in which the highly conserved Proline1851 in the RBD is mutated to glycine. Cell lysates were incubated with GST or GST-fused Ran proteins and immunoblotted with anti-HA antibody to identify Plexin B1 proteins, (n=3 with similar results)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)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COS7 cells were transiently co-transfected with plasmids encoding cytoPlexinB1-HA and</a:t>
            </a:r>
            <a:r>
              <a:rPr lang="en-GB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Cherry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Ran(WT) or FLAG-tagged Rnd2 (positive control for binding to the RBD of PlexinB1) or empty vector</a:t>
            </a:r>
            <a:r>
              <a:rPr lang="en-GB" sz="1200" i="1" strike="sngStrike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ell lysates were immunoprecipitated with anti-HA antibody bound to agarose beads. Immunoprecipitated proteins were analysed by immunoblotting with indicated antibodies (n=3 with similar results).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31734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80</Words>
  <Application>Microsoft Office PowerPoint</Application>
  <PresentationFormat>Widescreen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KC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gali Williamson</dc:creator>
  <cp:lastModifiedBy>Magali Williamson</cp:lastModifiedBy>
  <cp:revision>1</cp:revision>
  <dcterms:created xsi:type="dcterms:W3CDTF">2023-06-02T16:45:53Z</dcterms:created>
  <dcterms:modified xsi:type="dcterms:W3CDTF">2023-06-02T16:47:02Z</dcterms:modified>
</cp:coreProperties>
</file>